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2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4659"/>
  </p:normalViewPr>
  <p:slideViewPr>
    <p:cSldViewPr snapToGrid="0" snapToObjects="1">
      <p:cViewPr varScale="1">
        <p:scale>
          <a:sx n="50" d="100"/>
          <a:sy n="50" d="100"/>
        </p:scale>
        <p:origin x="231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210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387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64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810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033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881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404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202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741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106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634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272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7">
            <a:extLst>
              <a:ext uri="{FF2B5EF4-FFF2-40B4-BE49-F238E27FC236}">
                <a16:creationId xmlns:a16="http://schemas.microsoft.com/office/drawing/2014/main" id="{79BD60CD-7BF6-4AFA-88FA-1483CA9B70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834119"/>
              </p:ext>
            </p:extLst>
          </p:nvPr>
        </p:nvGraphicFramePr>
        <p:xfrm>
          <a:off x="103001" y="189439"/>
          <a:ext cx="6673976" cy="933276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83098">
                  <a:extLst>
                    <a:ext uri="{9D8B030D-6E8A-4147-A177-3AD203B41FA5}">
                      <a16:colId xmlns:a16="http://schemas.microsoft.com/office/drawing/2014/main" val="3247838079"/>
                    </a:ext>
                  </a:extLst>
                </a:gridCol>
                <a:gridCol w="3690878">
                  <a:extLst>
                    <a:ext uri="{9D8B030D-6E8A-4147-A177-3AD203B41FA5}">
                      <a16:colId xmlns:a16="http://schemas.microsoft.com/office/drawing/2014/main" val="3021798050"/>
                    </a:ext>
                  </a:extLst>
                </a:gridCol>
              </a:tblGrid>
              <a:tr h="359760">
                <a:tc gridSpan="2">
                  <a:txBody>
                    <a:bodyPr/>
                    <a:lstStyle/>
                    <a:p>
                      <a:r>
                        <a:rPr kumimoji="1" lang="en-US" altLang="ja-JP" dirty="0"/>
                        <a:t>Supplementary Table S2. Accession numbers of the genes used in the phylogenetic analysis</a:t>
                      </a:r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8560804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Gene name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Accession number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990720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Homo sapiens CTSL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244900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747183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enopus </a:t>
                      </a:r>
                      <a:r>
                        <a:rPr kumimoji="1" lang="en-US" altLang="ja-JP" dirty="0" err="1"/>
                        <a:t>laevis</a:t>
                      </a:r>
                      <a:r>
                        <a:rPr kumimoji="1" lang="en-US" altLang="ja-JP" dirty="0"/>
                        <a:t> CTSL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85736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014498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Finch CTSL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P_021386814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086857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Danio rerio CTSL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BC066490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239404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 err="1"/>
                        <a:t>Milii</a:t>
                      </a:r>
                      <a:r>
                        <a:rPr kumimoji="1" lang="en-US" altLang="ja-JP" dirty="0"/>
                        <a:t> CTSL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A0A4W3K499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6114583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 err="1"/>
                        <a:t>Scyliorhinus</a:t>
                      </a:r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torazame</a:t>
                      </a:r>
                      <a:r>
                        <a:rPr kumimoji="1" lang="en-US" altLang="ja-JP" dirty="0"/>
                        <a:t> CTSL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TRINITY_DN65741_c0_g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490200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 err="1"/>
                        <a:t>Scyliorhinus</a:t>
                      </a:r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torazame</a:t>
                      </a:r>
                      <a:r>
                        <a:rPr kumimoji="1" lang="en-US" altLang="ja-JP" dirty="0"/>
                        <a:t> CTSL2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PE_TRINITY_DN70779_c0_g1_i4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9244363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Danio rerio CTSK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17778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3356335"/>
                  </a:ext>
                </a:extLst>
              </a:tr>
              <a:tr h="338765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Gallus </a:t>
                      </a:r>
                      <a:r>
                        <a:rPr kumimoji="1" lang="en-US" altLang="ja-JP" dirty="0" err="1"/>
                        <a:t>gallus</a:t>
                      </a:r>
                      <a:r>
                        <a:rPr kumimoji="1" lang="en-US" altLang="ja-JP" dirty="0"/>
                        <a:t> CTSK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990302.2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5520305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Homo sapiens CTSK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0387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4028603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enopus tropicalis CTSK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72435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759316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Gallus </a:t>
                      </a:r>
                      <a:r>
                        <a:rPr kumimoji="1" lang="en-US" altLang="ja-JP" dirty="0" err="1"/>
                        <a:t>gallus</a:t>
                      </a:r>
                      <a:r>
                        <a:rPr kumimoji="1" lang="en-US" altLang="ja-JP" dirty="0"/>
                        <a:t> CTS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26516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1474638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Xenopus tropicalis CTS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05695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2481789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Homo sapiens CTS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186668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4973463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Medaka CTS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98157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287556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 err="1"/>
                        <a:t>Milii</a:t>
                      </a:r>
                      <a:r>
                        <a:rPr kumimoji="1" lang="en-US" altLang="ja-JP" dirty="0"/>
                        <a:t> CTSH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P_007903522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5708962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Gallus </a:t>
                      </a:r>
                      <a:r>
                        <a:rPr kumimoji="1" lang="en-US" altLang="ja-JP" dirty="0" err="1"/>
                        <a:t>gallus</a:t>
                      </a:r>
                      <a:r>
                        <a:rPr kumimoji="1" lang="en-US" altLang="ja-JP" dirty="0"/>
                        <a:t> CTSH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305336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0973044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Danio rerio CTSH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997853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4977023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Homo sapiens CTSH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306066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3322696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enopus </a:t>
                      </a:r>
                      <a:r>
                        <a:rPr kumimoji="1" lang="en-US" altLang="ja-JP" dirty="0" err="1"/>
                        <a:t>laevis</a:t>
                      </a:r>
                      <a:r>
                        <a:rPr kumimoji="1" lang="en-US" altLang="ja-JP" dirty="0"/>
                        <a:t> CTSH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91187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299680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enopus tropicalis CTSF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106423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2486722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Danio rerio CTSF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1071036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5287518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Homo sapiens CTSF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P_003784.2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8303540"/>
                  </a:ext>
                </a:extLst>
              </a:tr>
              <a:tr h="35976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Skate CTSF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XP_032871116.1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23030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95219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165</Words>
  <Application>Microsoft Office PowerPoint</Application>
  <PresentationFormat>A4 Paper (210x297 mm)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taru Takagi</dc:creator>
  <cp:lastModifiedBy>HYD OFF33</cp:lastModifiedBy>
  <cp:revision>12</cp:revision>
  <dcterms:created xsi:type="dcterms:W3CDTF">2021-11-22T08:43:41Z</dcterms:created>
  <dcterms:modified xsi:type="dcterms:W3CDTF">2022-03-08T03:24:21Z</dcterms:modified>
</cp:coreProperties>
</file>